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7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D4AC70-304F-444B-AC4D-8FB2B45C796E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17F8ED-852E-444C-A1F8-FE9B8C0F7C0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17F8ED-852E-444C-A1F8-FE9B8C0F7C0A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2164254" y="556155"/>
          <a:ext cx="5796697" cy="5286400"/>
        </p:xfrm>
        <a:graphic>
          <a:graphicData uri="http://schemas.openxmlformats.org/drawingml/2006/table">
            <a:tbl>
              <a:tblPr/>
              <a:tblGrid>
                <a:gridCol w="392767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  <a:gridCol w="257330"/>
              </a:tblGrid>
              <a:tr h="211456"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14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 rot="10800000">
            <a:off x="1687646" y="1283922"/>
            <a:ext cx="461665" cy="38949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Orange-spotted grouper linkage group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786182" y="214290"/>
            <a:ext cx="2726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tickleback chromosomes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</TotalTime>
  <Words>79</Words>
  <PresentationFormat>全屏显示(4:3)</PresentationFormat>
  <Paragraphs>552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dell</cp:lastModifiedBy>
  <cp:revision>5</cp:revision>
  <dcterms:modified xsi:type="dcterms:W3CDTF">2013-06-21T14:37:29Z</dcterms:modified>
</cp:coreProperties>
</file>